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38" d="100"/>
          <a:sy n="38" d="100"/>
        </p:scale>
        <p:origin x="56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B6A506-61F2-222D-B4FC-1AFEF9B036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681169C-8B33-0DD4-07FA-75B82710D86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3CBAE59-DAE8-2B2D-04B3-067E06FB6A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F9BC73-1D27-4E2F-428F-77AD8710E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5F85B4A-E818-B7AD-8F7E-B5EB0AA48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500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BF34CBA-2456-8DCF-454D-256CEB4621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0B370E8-7661-13F7-F013-96BC43DB30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ADFDD57-72F8-AD85-67BF-9308BD2D81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CB8444B-8F62-C391-B670-A309B54AA6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CEBDC94-3DD7-1028-D97C-AFF0D22C66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17297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2EDF023-267B-8951-8193-03A0C062C1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554943E-A160-D06B-B1AB-B7601BD7C2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128CDAC-8AAC-8C6D-C649-0697DBA46B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1B37BA6-2B3D-D364-5FDA-7EE4DD60DB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A446E3-2198-9A81-99B0-68BB8D9C64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04443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8472E5-15E5-E04D-8002-9A5C1A405F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20E3AE8-CF26-5DCA-D296-452FAD417A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E799B7-6A0C-D8ED-24B5-C1B805C4B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9E741B-D341-93D7-0972-98071F6ED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CFEEE2B-0DF9-102B-9F08-8F34F44A7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5772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5B2EAC-3DD2-9D9D-1609-5AF6466F79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15D927D-C2C0-1685-A47A-5C07C19F2A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5172B7B-612E-7CFD-726A-85221D68F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ABA443E-B241-6459-5A7E-C2D51063A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735CCF8-782D-A6B2-5D61-8C49A8C0CE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4370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D990EC-BB10-6CAC-7E52-9B58C1FDB6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0AB3CC1-E08C-A6EB-8313-36B4A21D7B3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4D357D9-7A55-42FE-FF58-B45EE78068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40FD1D-146F-3B3A-6046-4107B67F1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0A6A78-6DA7-820B-AB1C-1660A217B7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C92F127-D88C-6254-EB61-6BCE79C00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4185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AE57BAA-DA8A-8311-D8F3-7BDFCD3A63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F8778E1-77FA-B32E-DB88-BF59CA1464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CB72062-A9EB-677B-B8E4-C4D0961C0D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92913C0-A14F-9F39-970E-9800A088AB2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5F8BFDAC-0BDF-9963-9F00-E9675D3D76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6A6654C-19DE-8593-B260-D832CFA55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E722043-8496-0AFE-5A06-9FAB387845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3D572F2-9C15-A522-23A1-59292FD09F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2379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7FBA1B-1368-8937-F944-7415C8DD47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6022C2E-A317-A07B-6DE9-A50D79804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5294019-ABC0-DAF4-3980-A95F2D6176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87633B9-5363-F02A-6BBC-891307209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4457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AB60549-ADBF-DAFE-9659-71F327481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196CC44-0BBF-90CB-F32C-FDCE9C9F5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18A0EA5-C138-8535-22FD-80BCF2087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175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45B9F70-0616-1DE9-4BDF-65B5AD13E5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D52186A-C09E-C67F-0C5F-1DCFB4E47D8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B5119EA-4167-B8CD-4210-B74265A0A1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4FFECA5-214C-6950-0C1D-3760AA85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6C27E1-FF3F-8648-A1B9-88F87FF4EC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01DAAE1-6858-BEA6-A103-E68DCF3FFC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13422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A681C5C-BB38-D689-B964-DADABB630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16CB6061-C476-6468-781F-FB82C1A9AD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641E2DB-78AF-0E0B-141B-7FC169A5C3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5FDEEAA-8079-A5E9-9B57-11B94FC9E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72E9CD4-AFB4-0752-E18B-7E16C60AA7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F802D1F-7D7B-8194-BB19-31DB7CD854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42231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3F53AFD-D044-7894-CA67-7A6A4F58DF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386A1558-7AEC-F1E3-1397-04CEE7BFF3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5528AE-60D4-4461-DF96-A348D33560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D6AD34-8AFC-461B-B6F7-2DB5D5A14C74}" type="datetimeFigureOut">
              <a:rPr kumimoji="1" lang="ja-JP" altLang="en-US" smtClean="0"/>
              <a:t>2025/7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6E0020-4F56-7364-DEA3-C6564710531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0660D1-3662-EA02-5BD3-F0B484A4C1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60ECB-0088-4662-8EE6-12D1BADF42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88338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D89DEF-0505-0E17-121D-E4621DB2156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F23A940-FD62-6A35-9316-B41A3C39B8F6}"/>
              </a:ext>
            </a:extLst>
          </p:cNvPr>
          <p:cNvSpPr txBox="1"/>
          <p:nvPr/>
        </p:nvSpPr>
        <p:spPr>
          <a:xfrm>
            <a:off x="410358" y="6068399"/>
            <a:ext cx="7467109" cy="52322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altLang="ja-JP" sz="2800" dirty="0"/>
              <a:t>Obtained full text and examined the content</a:t>
            </a:r>
            <a:endParaRPr kumimoji="1" lang="ja-JP" altLang="en-US" sz="2800" dirty="0"/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839C0752-3BE9-693A-95BA-4AC773373782}"/>
              </a:ext>
            </a:extLst>
          </p:cNvPr>
          <p:cNvCxnSpPr>
            <a:cxnSpLocks/>
            <a:stCxn id="13" idx="2"/>
            <a:endCxn id="12" idx="0"/>
          </p:cNvCxnSpPr>
          <p:nvPr/>
        </p:nvCxnSpPr>
        <p:spPr>
          <a:xfrm>
            <a:off x="4143912" y="5821177"/>
            <a:ext cx="1" cy="24722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" name="フローチャート: 代替処理 3">
            <a:extLst>
              <a:ext uri="{FF2B5EF4-FFF2-40B4-BE49-F238E27FC236}">
                <a16:creationId xmlns:a16="http://schemas.microsoft.com/office/drawing/2014/main" id="{746E0113-D9E1-2FD9-3D8F-44F1837F43D9}"/>
              </a:ext>
            </a:extLst>
          </p:cNvPr>
          <p:cNvSpPr/>
          <p:nvPr/>
        </p:nvSpPr>
        <p:spPr>
          <a:xfrm>
            <a:off x="2497667" y="2957379"/>
            <a:ext cx="3292490" cy="562307"/>
          </a:xfrm>
          <a:prstGeom prst="flowChartAlternateProcess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2800" dirty="0"/>
              <a:t>502/127 articles</a:t>
            </a:r>
            <a:endParaRPr kumimoji="1" lang="ja-JP" altLang="en-US" sz="2800" dirty="0"/>
          </a:p>
        </p:txBody>
      </p:sp>
      <p:sp>
        <p:nvSpPr>
          <p:cNvPr id="2" name="フローチャート: 代替処理 1">
            <a:extLst>
              <a:ext uri="{FF2B5EF4-FFF2-40B4-BE49-F238E27FC236}">
                <a16:creationId xmlns:a16="http://schemas.microsoft.com/office/drawing/2014/main" id="{66CF0114-63BD-BF24-E114-213991D31A0E}"/>
              </a:ext>
            </a:extLst>
          </p:cNvPr>
          <p:cNvSpPr/>
          <p:nvPr/>
        </p:nvSpPr>
        <p:spPr>
          <a:xfrm>
            <a:off x="289459" y="266381"/>
            <a:ext cx="7708907" cy="954107"/>
          </a:xfrm>
          <a:prstGeom prst="flowChartAlternateProcess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2800" dirty="0"/>
              <a:t>“deep learning”</a:t>
            </a:r>
          </a:p>
          <a:p>
            <a:pPr algn="ctr"/>
            <a:r>
              <a:rPr lang="en-US" altLang="ja-JP" sz="2800" dirty="0"/>
              <a:t>“postoperative complications/mortality”</a:t>
            </a:r>
            <a:endParaRPr kumimoji="1" lang="ja-JP" altLang="en-US" sz="2800" dirty="0"/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8670BF84-101A-DFFB-93BC-6F42AAE29668}"/>
              </a:ext>
            </a:extLst>
          </p:cNvPr>
          <p:cNvCxnSpPr>
            <a:cxnSpLocks/>
            <a:stCxn id="2" idx="2"/>
            <a:endCxn id="4" idx="0"/>
          </p:cNvCxnSpPr>
          <p:nvPr/>
        </p:nvCxnSpPr>
        <p:spPr>
          <a:xfrm flipH="1">
            <a:off x="4143912" y="1220488"/>
            <a:ext cx="1" cy="1736891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46D6AF19-218F-E30C-CDB8-1CCFEFFC68EB}"/>
              </a:ext>
            </a:extLst>
          </p:cNvPr>
          <p:cNvCxnSpPr>
            <a:cxnSpLocks/>
            <a:stCxn id="4" idx="2"/>
            <a:endCxn id="13" idx="0"/>
          </p:cNvCxnSpPr>
          <p:nvPr/>
        </p:nvCxnSpPr>
        <p:spPr>
          <a:xfrm>
            <a:off x="4143912" y="3519686"/>
            <a:ext cx="0" cy="1739184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フローチャート: 代替処理 12">
            <a:extLst>
              <a:ext uri="{FF2B5EF4-FFF2-40B4-BE49-F238E27FC236}">
                <a16:creationId xmlns:a16="http://schemas.microsoft.com/office/drawing/2014/main" id="{D84CF55A-F171-AD8A-B8B8-AFD7AAAAFCA6}"/>
              </a:ext>
            </a:extLst>
          </p:cNvPr>
          <p:cNvSpPr/>
          <p:nvPr/>
        </p:nvSpPr>
        <p:spPr>
          <a:xfrm>
            <a:off x="2497667" y="5258870"/>
            <a:ext cx="3292490" cy="562307"/>
          </a:xfrm>
          <a:prstGeom prst="flowChartAlternateProcess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2800" dirty="0"/>
              <a:t>17/10 articles</a:t>
            </a:r>
            <a:endParaRPr kumimoji="1" lang="ja-JP" altLang="en-US" sz="2800" dirty="0"/>
          </a:p>
        </p:txBody>
      </p:sp>
      <p:sp>
        <p:nvSpPr>
          <p:cNvPr id="15" name="ひし形 14">
            <a:extLst>
              <a:ext uri="{FF2B5EF4-FFF2-40B4-BE49-F238E27FC236}">
                <a16:creationId xmlns:a16="http://schemas.microsoft.com/office/drawing/2014/main" id="{C81D302A-0F99-4225-B3B5-0B7E99BC8C15}"/>
              </a:ext>
            </a:extLst>
          </p:cNvPr>
          <p:cNvSpPr/>
          <p:nvPr/>
        </p:nvSpPr>
        <p:spPr>
          <a:xfrm>
            <a:off x="2002494" y="1467709"/>
            <a:ext cx="4282837" cy="1242449"/>
          </a:xfrm>
          <a:prstGeom prst="diamond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</a:rPr>
              <a:t>Searched on PubMed</a:t>
            </a:r>
            <a:r>
              <a:rPr lang="ja-JP" altLang="en-US" sz="2400" dirty="0">
                <a:solidFill>
                  <a:schemeClr val="tx1"/>
                </a:solidFill>
              </a:rPr>
              <a:t> </a:t>
            </a:r>
            <a:endParaRPr lang="en-US" altLang="ja-JP" sz="2400" dirty="0">
              <a:solidFill>
                <a:schemeClr val="tx1"/>
              </a:solidFill>
            </a:endParaRPr>
          </a:p>
        </p:txBody>
      </p:sp>
      <p:sp>
        <p:nvSpPr>
          <p:cNvPr id="16" name="ひし形 15">
            <a:extLst>
              <a:ext uri="{FF2B5EF4-FFF2-40B4-BE49-F238E27FC236}">
                <a16:creationId xmlns:a16="http://schemas.microsoft.com/office/drawing/2014/main" id="{F916BA96-6C5D-9755-EC59-5E69FDA89969}"/>
              </a:ext>
            </a:extLst>
          </p:cNvPr>
          <p:cNvSpPr/>
          <p:nvPr/>
        </p:nvSpPr>
        <p:spPr>
          <a:xfrm>
            <a:off x="1376135" y="3766907"/>
            <a:ext cx="5535555" cy="1244742"/>
          </a:xfrm>
          <a:prstGeom prst="diamond">
            <a:avLst/>
          </a:prstGeom>
          <a:solidFill>
            <a:schemeClr val="bg1"/>
          </a:solidFill>
          <a:ln w="285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2400" dirty="0">
                <a:solidFill>
                  <a:schemeClr val="tx1"/>
                </a:solidFill>
              </a:rPr>
              <a:t>Screened via</a:t>
            </a:r>
          </a:p>
          <a:p>
            <a:pPr algn="ctr"/>
            <a:r>
              <a:rPr lang="en-US" altLang="ja-JP" sz="2400" dirty="0">
                <a:solidFill>
                  <a:schemeClr val="tx1"/>
                </a:solidFill>
              </a:rPr>
              <a:t>title and abstract</a:t>
            </a:r>
          </a:p>
        </p:txBody>
      </p:sp>
      <p:sp>
        <p:nvSpPr>
          <p:cNvPr id="38" name="フローチャート: 代替処理 37">
            <a:extLst>
              <a:ext uri="{FF2B5EF4-FFF2-40B4-BE49-F238E27FC236}">
                <a16:creationId xmlns:a16="http://schemas.microsoft.com/office/drawing/2014/main" id="{FC9849EB-0891-F990-3A92-2B0BFD390D08}"/>
              </a:ext>
            </a:extLst>
          </p:cNvPr>
          <p:cNvSpPr/>
          <p:nvPr/>
        </p:nvSpPr>
        <p:spPr>
          <a:xfrm>
            <a:off x="7424290" y="3954435"/>
            <a:ext cx="4510354" cy="869685"/>
          </a:xfrm>
          <a:prstGeom prst="flowChartAlternateProcess">
            <a:avLst/>
          </a:prstGeom>
          <a:ln w="28575">
            <a:solidFill>
              <a:schemeClr val="tx1"/>
            </a:solidFill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altLang="ja-JP" sz="2400" dirty="0" err="1"/>
              <a:t>Conmtents</a:t>
            </a:r>
            <a:r>
              <a:rPr lang="en-US" altLang="ja-JP" sz="2400" dirty="0"/>
              <a:t> did not matched </a:t>
            </a:r>
          </a:p>
          <a:p>
            <a:pPr algn="ctr"/>
            <a:r>
              <a:rPr lang="en-US" altLang="ja-JP" sz="2400" dirty="0"/>
              <a:t>(485/117 articles)</a:t>
            </a:r>
            <a:endParaRPr kumimoji="1" lang="ja-JP" altLang="en-US" sz="2400" dirty="0"/>
          </a:p>
        </p:txBody>
      </p: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A3350812-C9BF-0ECB-4ED1-4F0802EC36E8}"/>
              </a:ext>
            </a:extLst>
          </p:cNvPr>
          <p:cNvCxnSpPr>
            <a:cxnSpLocks/>
            <a:stCxn id="16" idx="3"/>
            <a:endCxn id="38" idx="1"/>
          </p:cNvCxnSpPr>
          <p:nvPr/>
        </p:nvCxnSpPr>
        <p:spPr>
          <a:xfrm>
            <a:off x="6911690" y="4389278"/>
            <a:ext cx="5126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83425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</TotalTime>
  <Words>37</Words>
  <Application>Microsoft Office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yousuke fukuyo</dc:creator>
  <cp:lastModifiedBy>ryousuke fukuyo</cp:lastModifiedBy>
  <cp:revision>5</cp:revision>
  <dcterms:created xsi:type="dcterms:W3CDTF">2025-07-21T07:34:18Z</dcterms:created>
  <dcterms:modified xsi:type="dcterms:W3CDTF">2025-07-22T15:11:51Z</dcterms:modified>
</cp:coreProperties>
</file>